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jpeg" ContentType="image/jpeg"/>
  <Override PartName="/ppt/media/image2.jpeg" ContentType="image/jpeg"/>
  <Override PartName="/ppt/media/image3.jpeg" ContentType="image/jpeg"/>
  <Override PartName="/ppt/media/image4.jpeg" ContentType="image/jpeg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2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</p:sldIdLst>
  <p:sldSz cx="6858000" cy="9907588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1B88823-DBD5-4534-BA2E-E64CC391DA81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514440" y="880560"/>
            <a:ext cx="582912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514440" y="2862360"/>
            <a:ext cx="5829120" cy="2835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514440" y="5967000"/>
            <a:ext cx="5829120" cy="2835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F2D2C20-F138-40D1-BC32-00DBCD3BB9E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514440" y="880560"/>
            <a:ext cx="582912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514440" y="2862360"/>
            <a:ext cx="2844360" cy="2835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1360" y="2862360"/>
            <a:ext cx="2844360" cy="2835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514440" y="5967000"/>
            <a:ext cx="2844360" cy="2835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1360" y="5967000"/>
            <a:ext cx="2844360" cy="2835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FBDCAA5-43C4-4A86-821A-F155E09B1906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514440" y="880560"/>
            <a:ext cx="582912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514440" y="2862360"/>
            <a:ext cx="1876680" cy="2835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85440" y="2862360"/>
            <a:ext cx="1876680" cy="2835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456080" y="2862360"/>
            <a:ext cx="1876680" cy="2835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514440" y="5967000"/>
            <a:ext cx="1876680" cy="2835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85440" y="5967000"/>
            <a:ext cx="1876680" cy="2835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456080" y="5967000"/>
            <a:ext cx="1876680" cy="2835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9E58180-60A4-4C86-9F12-8AA02288E4F9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514440" y="880560"/>
            <a:ext cx="582912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514440" y="2862360"/>
            <a:ext cx="5829120" cy="59436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32DDD2F-E854-4F00-85A1-C60639E7DADF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514440" y="880560"/>
            <a:ext cx="582912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514440" y="2862360"/>
            <a:ext cx="5829120" cy="5943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C2AD48C-6286-4045-B67E-E06F04B6B33A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514440" y="880560"/>
            <a:ext cx="582912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514440" y="2862360"/>
            <a:ext cx="2844360" cy="5943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1360" y="2862360"/>
            <a:ext cx="2844360" cy="5943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7680B4A-8BD7-4D04-8959-F918EA1A970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514440" y="880560"/>
            <a:ext cx="582912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0F9B5E1-8AC9-4B7F-9E73-3F07B6C14083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514440" y="880560"/>
            <a:ext cx="5829120" cy="76557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911505D-9C0A-4300-AEE3-ECEB96F45A6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514440" y="880560"/>
            <a:ext cx="582912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514440" y="2862360"/>
            <a:ext cx="2844360" cy="2835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1360" y="2862360"/>
            <a:ext cx="2844360" cy="5943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514440" y="5967000"/>
            <a:ext cx="2844360" cy="2835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F303A3E-E88F-4866-B244-428E01B4909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514440" y="880560"/>
            <a:ext cx="582912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514440" y="2862360"/>
            <a:ext cx="2844360" cy="5943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1360" y="2862360"/>
            <a:ext cx="2844360" cy="2835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1360" y="5967000"/>
            <a:ext cx="2844360" cy="2835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60D22AE-8C01-4305-BFAA-AAEED98B863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514440" y="880560"/>
            <a:ext cx="582912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514440" y="2862360"/>
            <a:ext cx="2844360" cy="2835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1360" y="2862360"/>
            <a:ext cx="2844360" cy="2835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514440" y="5967000"/>
            <a:ext cx="5829120" cy="2835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ECEFDCE-4568-4229-9B49-88B7D71B90C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514440" y="880560"/>
            <a:ext cx="582912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Times New Roman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514440" y="2862360"/>
            <a:ext cx="5829120" cy="5943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Times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Times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Times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Times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Times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Times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Times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514080" y="9024480"/>
            <a:ext cx="1428840" cy="660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9024480"/>
            <a:ext cx="2171520" cy="660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5080" y="9024480"/>
            <a:ext cx="1428480" cy="660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5F5685D0-E47E-439B-93AC-76F13522989E}" type="slidenum"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image" Target="../media/image2.jpeg"/><Relationship Id="rId3" Type="http://schemas.openxmlformats.org/officeDocument/2006/relationships/image" Target="../media/image3.jpeg"/><Relationship Id="rId4" Type="http://schemas.openxmlformats.org/officeDocument/2006/relationships/image" Target="../media/image4.jpeg"/><Relationship Id="rId5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574560" y="318960"/>
            <a:ext cx="571500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Times New Roman"/>
              </a:rPr>
              <a:t>Supplementary figure S1A.</a:t>
            </a:r>
            <a:r>
              <a:rPr b="0" lang="en-GB" sz="1200" spc="-1" strike="noStrike">
                <a:solidFill>
                  <a:srgbClr val="000000"/>
                </a:solidFill>
                <a:latin typeface="Times New Roman"/>
              </a:rPr>
              <a:t> Relative levels of EBER1 expression in the EµEBER1 transgenic lines.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pic>
        <p:nvPicPr>
          <p:cNvPr id="42" name="" descr=""/>
          <p:cNvPicPr/>
          <p:nvPr/>
        </p:nvPicPr>
        <p:blipFill>
          <a:blip r:embed="rId1"/>
          <a:stretch/>
        </p:blipFill>
        <p:spPr>
          <a:xfrm>
            <a:off x="812880" y="1143000"/>
            <a:ext cx="4533840" cy="2125800"/>
          </a:xfrm>
          <a:prstGeom prst="rect">
            <a:avLst/>
          </a:prstGeom>
          <a:ln w="0">
            <a:noFill/>
          </a:ln>
        </p:spPr>
      </p:pic>
      <p:sp>
        <p:nvSpPr>
          <p:cNvPr id="43" name=""/>
          <p:cNvSpPr/>
          <p:nvPr/>
        </p:nvSpPr>
        <p:spPr>
          <a:xfrm>
            <a:off x="5486040" y="1127160"/>
            <a:ext cx="807120" cy="1798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</a:rPr>
              <a:t>1/50 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</a:rPr>
              <a:t>AK2003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</a:rPr>
              <a:t>127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</a:rPr>
              <a:t>142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</a:rPr>
              <a:t>136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</a:rPr>
              <a:t>AK31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4" name=""/>
          <p:cNvSpPr/>
          <p:nvPr/>
        </p:nvSpPr>
        <p:spPr>
          <a:xfrm>
            <a:off x="1662480" y="1320840"/>
            <a:ext cx="156132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Times New Roman"/>
              </a:rPr>
              <a:t>Peyer’s patch</a:t>
            </a:r>
            <a:endParaRPr b="0" lang="en-US" sz="2000" spc="-1" strike="noStrike">
              <a:solidFill>
                <a:srgbClr val="000000"/>
              </a:solidFill>
              <a:latin typeface="Times New Roman"/>
            </a:endParaRPr>
          </a:p>
        </p:txBody>
      </p:sp>
      <p:pic>
        <p:nvPicPr>
          <p:cNvPr id="45" name="" descr=""/>
          <p:cNvPicPr/>
          <p:nvPr/>
        </p:nvPicPr>
        <p:blipFill>
          <a:blip r:embed="rId2"/>
          <a:stretch/>
        </p:blipFill>
        <p:spPr>
          <a:xfrm>
            <a:off x="812880" y="3392640"/>
            <a:ext cx="4543200" cy="1908000"/>
          </a:xfrm>
          <a:prstGeom prst="rect">
            <a:avLst/>
          </a:prstGeom>
          <a:ln w="0">
            <a:noFill/>
          </a:ln>
        </p:spPr>
      </p:pic>
      <p:sp>
        <p:nvSpPr>
          <p:cNvPr id="46" name=""/>
          <p:cNvSpPr/>
          <p:nvPr/>
        </p:nvSpPr>
        <p:spPr>
          <a:xfrm>
            <a:off x="1662480" y="3517920"/>
            <a:ext cx="156132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Times New Roman"/>
              </a:rPr>
              <a:t>Peyer’s patch</a:t>
            </a:r>
            <a:endParaRPr b="0" lang="en-US" sz="2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7" name=""/>
          <p:cNvSpPr/>
          <p:nvPr/>
        </p:nvSpPr>
        <p:spPr>
          <a:xfrm>
            <a:off x="5487120" y="3362400"/>
            <a:ext cx="627120" cy="15861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</a:rPr>
              <a:t>127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</a:rPr>
              <a:t>131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</a:rPr>
              <a:t>137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</a:rPr>
              <a:t>AK31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grpSp>
        <p:nvGrpSpPr>
          <p:cNvPr id="48" name=""/>
          <p:cNvGrpSpPr/>
          <p:nvPr/>
        </p:nvGrpSpPr>
        <p:grpSpPr>
          <a:xfrm>
            <a:off x="812880" y="7553160"/>
            <a:ext cx="5301360" cy="1871640"/>
            <a:chOff x="812880" y="7553160"/>
            <a:chExt cx="5301360" cy="1871640"/>
          </a:xfrm>
        </p:grpSpPr>
        <p:pic>
          <p:nvPicPr>
            <p:cNvPr id="49" name="" descr=""/>
            <p:cNvPicPr/>
            <p:nvPr/>
          </p:nvPicPr>
          <p:blipFill>
            <a:blip r:embed="rId3"/>
            <a:stretch/>
          </p:blipFill>
          <p:spPr>
            <a:xfrm>
              <a:off x="812880" y="7581960"/>
              <a:ext cx="4552920" cy="184284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50" name=""/>
            <p:cNvSpPr/>
            <p:nvPr/>
          </p:nvSpPr>
          <p:spPr>
            <a:xfrm>
              <a:off x="1676520" y="7746840"/>
              <a:ext cx="932040" cy="398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000" spc="-1" strike="noStrike">
                  <a:solidFill>
                    <a:srgbClr val="000000"/>
                  </a:solidFill>
                  <a:latin typeface="Times New Roman"/>
                </a:rPr>
                <a:t>thymus</a:t>
              </a:r>
              <a:endParaRPr b="0" lang="en-US" sz="2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1" name=""/>
            <p:cNvSpPr/>
            <p:nvPr/>
          </p:nvSpPr>
          <p:spPr>
            <a:xfrm>
              <a:off x="5487120" y="7553160"/>
              <a:ext cx="627120" cy="17082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Times New Roman"/>
                </a:rPr>
                <a:t>127 </a:t>
              </a:r>
              <a:endParaRPr b="0" lang="en-US" sz="1400" spc="-1" strike="noStrike">
                <a:solidFill>
                  <a:srgbClr val="000000"/>
                </a:solidFill>
                <a:latin typeface="Times New Roman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Times New Roman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Times New Roman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Times New Roman"/>
                </a:rPr>
                <a:t>131 </a:t>
              </a:r>
              <a:endParaRPr b="0" lang="en-US" sz="1400" spc="-1" strike="noStrike">
                <a:solidFill>
                  <a:srgbClr val="000000"/>
                </a:solidFill>
                <a:latin typeface="Times New Roman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400" spc="-1" strike="noStrike">
                <a:solidFill>
                  <a:srgbClr val="000000"/>
                </a:solidFill>
                <a:latin typeface="Times New Roman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Times New Roman"/>
                </a:rPr>
                <a:t>137 </a:t>
              </a:r>
              <a:endParaRPr b="0" lang="en-US" sz="1400" spc="-1" strike="noStrike">
                <a:solidFill>
                  <a:srgbClr val="000000"/>
                </a:solidFill>
                <a:latin typeface="Times New Roman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Times New Roman"/>
                </a:rPr>
                <a:t>AK31</a:t>
              </a:r>
              <a:endParaRPr b="0" lang="en-US" sz="1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</p:grpSp>
      <p:grpSp>
        <p:nvGrpSpPr>
          <p:cNvPr id="52" name=""/>
          <p:cNvGrpSpPr/>
          <p:nvPr/>
        </p:nvGrpSpPr>
        <p:grpSpPr>
          <a:xfrm>
            <a:off x="812880" y="5330880"/>
            <a:ext cx="5492880" cy="2123640"/>
            <a:chOff x="812880" y="5330880"/>
            <a:chExt cx="5492880" cy="2123640"/>
          </a:xfrm>
        </p:grpSpPr>
        <p:pic>
          <p:nvPicPr>
            <p:cNvPr id="53" name="" descr=""/>
            <p:cNvPicPr/>
            <p:nvPr/>
          </p:nvPicPr>
          <p:blipFill>
            <a:blip r:embed="rId4"/>
            <a:stretch/>
          </p:blipFill>
          <p:spPr>
            <a:xfrm>
              <a:off x="812880" y="5410080"/>
              <a:ext cx="4571640" cy="204444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54" name=""/>
            <p:cNvSpPr/>
            <p:nvPr/>
          </p:nvSpPr>
          <p:spPr>
            <a:xfrm>
              <a:off x="5498640" y="5330880"/>
              <a:ext cx="807120" cy="1798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Times New Roman"/>
                </a:rPr>
                <a:t>1/50 </a:t>
              </a:r>
              <a:endParaRPr b="0" lang="en-US" sz="1400" spc="-1" strike="noStrike">
                <a:solidFill>
                  <a:srgbClr val="000000"/>
                </a:solidFill>
                <a:latin typeface="Times New Roman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Times New Roman"/>
                </a:rPr>
                <a:t>AK2003</a:t>
              </a:r>
              <a:endParaRPr b="0" lang="en-US" sz="1400" spc="-1" strike="noStrike">
                <a:solidFill>
                  <a:srgbClr val="000000"/>
                </a:solidFill>
                <a:latin typeface="Times New Roman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400" spc="-1" strike="noStrike">
                <a:solidFill>
                  <a:srgbClr val="000000"/>
                </a:solidFill>
                <a:latin typeface="Times New Roman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400" spc="-1" strike="noStrike">
                <a:solidFill>
                  <a:srgbClr val="000000"/>
                </a:solidFill>
                <a:latin typeface="Times New Roman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Times New Roman"/>
                </a:rPr>
                <a:t>142</a:t>
              </a:r>
              <a:endParaRPr b="0" lang="en-US" sz="1400" spc="-1" strike="noStrike">
                <a:solidFill>
                  <a:srgbClr val="000000"/>
                </a:solidFill>
                <a:latin typeface="Times New Roman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Times New Roman"/>
                </a:rPr>
                <a:t>127</a:t>
              </a:r>
              <a:endParaRPr b="0" lang="en-US" sz="1400" spc="-1" strike="noStrike">
                <a:solidFill>
                  <a:srgbClr val="000000"/>
                </a:solidFill>
                <a:latin typeface="Times New Roman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Times New Roman"/>
                </a:rPr>
                <a:t>136 </a:t>
              </a:r>
              <a:endParaRPr b="0" lang="en-US" sz="1400" spc="-1" strike="noStrike">
                <a:solidFill>
                  <a:srgbClr val="000000"/>
                </a:solidFill>
                <a:latin typeface="Times New Roman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Times New Roman"/>
                </a:rPr>
                <a:t>AK31</a:t>
              </a:r>
              <a:endParaRPr b="0" lang="en-US" sz="1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5" name=""/>
            <p:cNvSpPr/>
            <p:nvPr/>
          </p:nvSpPr>
          <p:spPr>
            <a:xfrm>
              <a:off x="1663200" y="5575320"/>
              <a:ext cx="932040" cy="398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000" spc="-1" strike="noStrike">
                  <a:solidFill>
                    <a:srgbClr val="000000"/>
                  </a:solidFill>
                  <a:latin typeface="Times New Roman"/>
                </a:rPr>
                <a:t>thymus</a:t>
              </a:r>
              <a:endParaRPr b="0" lang="en-US" sz="2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</p:grpSp>
      <p:sp>
        <p:nvSpPr>
          <p:cNvPr id="56" name=""/>
          <p:cNvSpPr/>
          <p:nvPr/>
        </p:nvSpPr>
        <p:spPr>
          <a:xfrm>
            <a:off x="416520" y="1952640"/>
            <a:ext cx="436680" cy="6676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Times New Roman"/>
              </a:rPr>
              <a:t>i</a:t>
            </a: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Times New Roman"/>
              </a:rPr>
              <a:t>ii</a:t>
            </a: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6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6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6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Times New Roman"/>
              </a:rPr>
              <a:t>iii</a:t>
            </a: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Times New Roman"/>
              </a:rPr>
              <a:t>iv</a:t>
            </a: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7" name=""/>
          <p:cNvSpPr/>
          <p:nvPr/>
        </p:nvSpPr>
        <p:spPr>
          <a:xfrm>
            <a:off x="574560" y="496800"/>
            <a:ext cx="571500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Times New Roman"/>
              </a:rPr>
              <a:t>Supplementary figure S1B.</a:t>
            </a:r>
            <a:r>
              <a:rPr b="0" lang="en-GB" sz="1200" spc="-1" strike="noStrike">
                <a:solidFill>
                  <a:srgbClr val="000000"/>
                </a:solidFill>
                <a:latin typeface="Times New Roman"/>
              </a:rPr>
              <a:t> Relative levels of EBER1 expression in the EµEBER1 transgenic lines.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grpSp>
        <p:nvGrpSpPr>
          <p:cNvPr id="58" name=""/>
          <p:cNvGrpSpPr/>
          <p:nvPr/>
        </p:nvGrpSpPr>
        <p:grpSpPr>
          <a:xfrm>
            <a:off x="716760" y="1193760"/>
            <a:ext cx="2648880" cy="1739880"/>
            <a:chOff x="716760" y="1193760"/>
            <a:chExt cx="2648880" cy="1739880"/>
          </a:xfrm>
        </p:grpSpPr>
        <p:sp>
          <p:nvSpPr>
            <p:cNvPr id="59" name=""/>
            <p:cNvSpPr/>
            <p:nvPr/>
          </p:nvSpPr>
          <p:spPr>
            <a:xfrm>
              <a:off x="2736720" y="1816200"/>
              <a:ext cx="628920" cy="398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2000" spc="-1" strike="noStrike">
                  <a:solidFill>
                    <a:srgbClr val="ff0b02"/>
                  </a:solidFill>
                  <a:latin typeface="Times New Roman"/>
                </a:rPr>
                <a:t>2.2x</a:t>
              </a:r>
              <a:endParaRPr b="0" lang="en-US" sz="2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0" name=""/>
            <p:cNvSpPr/>
            <p:nvPr/>
          </p:nvSpPr>
          <p:spPr>
            <a:xfrm>
              <a:off x="2755800" y="2387520"/>
              <a:ext cx="564840" cy="398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2000" spc="-1" strike="noStrike">
                  <a:solidFill>
                    <a:srgbClr val="ff0b02"/>
                  </a:solidFill>
                  <a:latin typeface="Times New Roman"/>
                </a:rPr>
                <a:t>53x</a:t>
              </a:r>
              <a:endParaRPr b="0" lang="en-US" sz="2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1" name=""/>
            <p:cNvSpPr/>
            <p:nvPr/>
          </p:nvSpPr>
          <p:spPr>
            <a:xfrm>
              <a:off x="2571840" y="2336760"/>
              <a:ext cx="152280" cy="533520"/>
            </a:xfrm>
            <a:custGeom>
              <a:avLst/>
              <a:gdLst>
                <a:gd name="textAreaLeft" fmla="*/ 20160 w 152280"/>
                <a:gd name="textAreaRight" fmla="*/ 132120 w 152280"/>
                <a:gd name="textAreaTop" fmla="*/ 93240 h 533520"/>
                <a:gd name="textAreaBottom" fmla="*/ 387000 h 533520"/>
              </a:gdLst>
              <a:ahLst/>
              <a:rect l="textAreaLeft" t="textAreaTop" r="textAreaRight" b="textAreaBottom"/>
              <a:pathLst>
                <a:path w="21600" h="21600">
                  <a:moveTo>
                    <a:pt x="0" y="0"/>
                  </a:moveTo>
                  <a:arcTo wR="21600" hR="7560" stAng="-5400000" swAng="5400000"/>
                  <a:lnTo>
                    <a:pt x="21600" y="11880"/>
                  </a:lnTo>
                  <a:arcTo wR="21600" hR="7560" stAng="0" swAng="2682637"/>
                  <a:lnTo>
                    <a:pt x="7200" y="21168"/>
                  </a:lnTo>
                  <a:lnTo>
                    <a:pt x="0" y="17280"/>
                  </a:lnTo>
                  <a:lnTo>
                    <a:pt x="7200" y="12528"/>
                  </a:lnTo>
                  <a:lnTo>
                    <a:pt x="7200" y="14688"/>
                  </a:lnTo>
                  <a:arcTo wR="21600" hR="7560" stAng="2682637" swAng="-2325203"/>
                  <a:lnTo>
                    <a:pt x="20700" y="9720"/>
                  </a:lnTo>
                  <a:arcTo wR="21600" hR="7560" stAng="-357435" swAng="-5042565"/>
                  <a:close/>
                </a:path>
                <a:path fill="darkenLess" w="21600" h="21600">
                  <a:moveTo>
                    <a:pt x="0" y="0"/>
                  </a:moveTo>
                  <a:arcTo wR="21600" hR="7560" stAng="-5400000" swAng="5400000"/>
                  <a:lnTo>
                    <a:pt x="21600" y="11880"/>
                  </a:lnTo>
                  <a:arcTo wR="21600" hR="7560" stAng="0" swAng="-357435"/>
                  <a:lnTo>
                    <a:pt x="20700" y="9720"/>
                  </a:lnTo>
                  <a:arcTo wR="21600" hR="7560" stAng="-357435" swAng="-5042565"/>
                  <a:close/>
                </a:path>
              </a:pathLst>
            </a:custGeom>
            <a:solidFill>
              <a:srgbClr val="bbe0e3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2" name=""/>
            <p:cNvSpPr/>
            <p:nvPr/>
          </p:nvSpPr>
          <p:spPr>
            <a:xfrm>
              <a:off x="2546280" y="1790640"/>
              <a:ext cx="152280" cy="533520"/>
            </a:xfrm>
            <a:custGeom>
              <a:avLst/>
              <a:gdLst>
                <a:gd name="textAreaLeft" fmla="*/ 20160 w 152280"/>
                <a:gd name="textAreaRight" fmla="*/ 132120 w 152280"/>
                <a:gd name="textAreaTop" fmla="*/ 93240 h 533520"/>
                <a:gd name="textAreaBottom" fmla="*/ 387000 h 533520"/>
              </a:gdLst>
              <a:ahLst/>
              <a:rect l="textAreaLeft" t="textAreaTop" r="textAreaRight" b="textAreaBottom"/>
              <a:pathLst>
                <a:path w="21600" h="21600">
                  <a:moveTo>
                    <a:pt x="0" y="0"/>
                  </a:moveTo>
                  <a:arcTo wR="21600" hR="7560" stAng="-5400000" swAng="5400000"/>
                  <a:lnTo>
                    <a:pt x="21600" y="11880"/>
                  </a:lnTo>
                  <a:arcTo wR="21600" hR="7560" stAng="0" swAng="2682637"/>
                  <a:lnTo>
                    <a:pt x="7200" y="21168"/>
                  </a:lnTo>
                  <a:lnTo>
                    <a:pt x="0" y="17280"/>
                  </a:lnTo>
                  <a:lnTo>
                    <a:pt x="7200" y="12528"/>
                  </a:lnTo>
                  <a:lnTo>
                    <a:pt x="7200" y="14688"/>
                  </a:lnTo>
                  <a:arcTo wR="21600" hR="7560" stAng="2682637" swAng="-2325203"/>
                  <a:lnTo>
                    <a:pt x="20700" y="9720"/>
                  </a:lnTo>
                  <a:arcTo wR="21600" hR="7560" stAng="-357435" swAng="-5042565"/>
                  <a:close/>
                </a:path>
                <a:path fill="darkenLess" w="21600" h="21600">
                  <a:moveTo>
                    <a:pt x="0" y="0"/>
                  </a:moveTo>
                  <a:arcTo wR="21600" hR="7560" stAng="-5400000" swAng="5400000"/>
                  <a:lnTo>
                    <a:pt x="21600" y="11880"/>
                  </a:lnTo>
                  <a:arcTo wR="21600" hR="7560" stAng="0" swAng="-357435"/>
                  <a:lnTo>
                    <a:pt x="20700" y="9720"/>
                  </a:lnTo>
                  <a:arcTo wR="21600" hR="7560" stAng="-357435" swAng="-5042565"/>
                  <a:close/>
                </a:path>
              </a:pathLst>
            </a:custGeom>
            <a:solidFill>
              <a:srgbClr val="bbe0e3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3" name=""/>
            <p:cNvSpPr/>
            <p:nvPr/>
          </p:nvSpPr>
          <p:spPr>
            <a:xfrm>
              <a:off x="716760" y="1193760"/>
              <a:ext cx="1811520" cy="1739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5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 u="sng">
                  <a:solidFill>
                    <a:srgbClr val="000000"/>
                  </a:solidFill>
                  <a:uFillTx/>
                  <a:latin typeface="Times New Roman"/>
                </a:rPr>
                <a:t>i Normalised data</a:t>
              </a:r>
              <a:endParaRPr b="0" lang="en-US" sz="1800" spc="-1" strike="noStrike">
                <a:solidFill>
                  <a:srgbClr val="000000"/>
                </a:solidFill>
                <a:latin typeface="Times New Roman"/>
              </a:endParaRPr>
            </a:p>
            <a:p>
              <a:pPr>
                <a:lnSpc>
                  <a:spcPct val="15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Times New Roman"/>
                </a:rPr>
                <a:t>127 PP: 7.8 10</a:t>
              </a:r>
              <a:r>
                <a:rPr b="0" lang="en-US" sz="1800" spc="-1" strike="noStrike" baseline="30000">
                  <a:solidFill>
                    <a:srgbClr val="000000"/>
                  </a:solidFill>
                  <a:latin typeface="Times New Roman"/>
                </a:rPr>
                <a:t>-10</a:t>
              </a:r>
              <a:endParaRPr b="0" lang="en-US" sz="1800" spc="-1" strike="noStrike">
                <a:solidFill>
                  <a:srgbClr val="000000"/>
                </a:solidFill>
                <a:latin typeface="Times New Roman"/>
              </a:endParaRPr>
            </a:p>
            <a:p>
              <a:pPr>
                <a:lnSpc>
                  <a:spcPct val="15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Times New Roman"/>
                </a:rPr>
                <a:t>142 PP: 3.5 10</a:t>
              </a:r>
              <a:r>
                <a:rPr b="0" lang="en-US" sz="1800" spc="-1" strike="noStrike" baseline="30000">
                  <a:solidFill>
                    <a:srgbClr val="000000"/>
                  </a:solidFill>
                  <a:latin typeface="Times New Roman"/>
                </a:rPr>
                <a:t>-10</a:t>
              </a:r>
              <a:endParaRPr b="0" lang="en-US" sz="1800" spc="-1" strike="noStrike">
                <a:solidFill>
                  <a:srgbClr val="000000"/>
                </a:solidFill>
                <a:latin typeface="Times New Roman"/>
              </a:endParaRPr>
            </a:p>
            <a:p>
              <a:pPr>
                <a:lnSpc>
                  <a:spcPct val="15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Times New Roman"/>
                </a:rPr>
                <a:t>136 PP: 6.5 10</a:t>
              </a:r>
              <a:r>
                <a:rPr b="0" lang="en-US" sz="1800" spc="-1" strike="noStrike" baseline="30000">
                  <a:solidFill>
                    <a:srgbClr val="000000"/>
                  </a:solidFill>
                  <a:latin typeface="Times New Roman"/>
                </a:rPr>
                <a:t>-12</a:t>
              </a:r>
              <a:endParaRPr b="0" lang="en-US" sz="1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</p:grpSp>
      <p:grpSp>
        <p:nvGrpSpPr>
          <p:cNvPr id="64" name=""/>
          <p:cNvGrpSpPr/>
          <p:nvPr/>
        </p:nvGrpSpPr>
        <p:grpSpPr>
          <a:xfrm>
            <a:off x="717480" y="3390840"/>
            <a:ext cx="2578680" cy="1739880"/>
            <a:chOff x="717480" y="3390840"/>
            <a:chExt cx="2578680" cy="1739880"/>
          </a:xfrm>
        </p:grpSpPr>
        <p:sp>
          <p:nvSpPr>
            <p:cNvPr id="65" name=""/>
            <p:cNvSpPr/>
            <p:nvPr/>
          </p:nvSpPr>
          <p:spPr>
            <a:xfrm>
              <a:off x="717480" y="3390840"/>
              <a:ext cx="2013120" cy="1739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5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 u="sng">
                  <a:solidFill>
                    <a:srgbClr val="000000"/>
                  </a:solidFill>
                  <a:uFillTx/>
                  <a:latin typeface="Times New Roman"/>
                </a:rPr>
                <a:t>iii Normalised data</a:t>
              </a:r>
              <a:endParaRPr b="0" lang="en-US" sz="1800" spc="-1" strike="noStrike">
                <a:solidFill>
                  <a:srgbClr val="000000"/>
                </a:solidFill>
                <a:latin typeface="Times New Roman"/>
              </a:endParaRPr>
            </a:p>
            <a:p>
              <a:pPr>
                <a:lnSpc>
                  <a:spcPct val="15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Times New Roman"/>
                </a:rPr>
                <a:t>142 T: 1 10</a:t>
              </a:r>
              <a:r>
                <a:rPr b="0" lang="en-US" sz="1800" spc="-1" strike="noStrike" baseline="30000">
                  <a:solidFill>
                    <a:srgbClr val="000000"/>
                  </a:solidFill>
                  <a:latin typeface="Times New Roman"/>
                </a:rPr>
                <a:t>-8</a:t>
              </a:r>
              <a:endParaRPr b="0" lang="en-US" sz="1800" spc="-1" strike="noStrike">
                <a:solidFill>
                  <a:srgbClr val="000000"/>
                </a:solidFill>
                <a:latin typeface="Times New Roman"/>
              </a:endParaRPr>
            </a:p>
            <a:p>
              <a:pPr>
                <a:lnSpc>
                  <a:spcPct val="15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Times New Roman"/>
                </a:rPr>
                <a:t>127 T: 1.1 10</a:t>
              </a:r>
              <a:r>
                <a:rPr b="0" lang="en-US" sz="1800" spc="-1" strike="noStrike" baseline="30000">
                  <a:solidFill>
                    <a:srgbClr val="000000"/>
                  </a:solidFill>
                  <a:latin typeface="Times New Roman"/>
                </a:rPr>
                <a:t>-9</a:t>
              </a:r>
              <a:endParaRPr b="0" lang="en-US" sz="1800" spc="-1" strike="noStrike">
                <a:solidFill>
                  <a:srgbClr val="000000"/>
                </a:solidFill>
                <a:latin typeface="Times New Roman"/>
              </a:endParaRPr>
            </a:p>
            <a:p>
              <a:pPr>
                <a:lnSpc>
                  <a:spcPct val="15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Times New Roman"/>
                </a:rPr>
                <a:t>136 T: 1.5 10</a:t>
              </a:r>
              <a:r>
                <a:rPr b="0" lang="en-US" sz="1800" spc="-1" strike="noStrike" baseline="30000">
                  <a:solidFill>
                    <a:srgbClr val="000000"/>
                  </a:solidFill>
                  <a:latin typeface="Times New Roman"/>
                </a:rPr>
                <a:t>-12</a:t>
              </a:r>
              <a:endParaRPr b="0" lang="en-US" sz="1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6" name=""/>
            <p:cNvSpPr/>
            <p:nvPr/>
          </p:nvSpPr>
          <p:spPr>
            <a:xfrm>
              <a:off x="2585160" y="4013280"/>
              <a:ext cx="436680" cy="398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2000" spc="-1" strike="noStrike">
                  <a:solidFill>
                    <a:srgbClr val="ff0b02"/>
                  </a:solidFill>
                  <a:latin typeface="Times New Roman"/>
                </a:rPr>
                <a:t>9x</a:t>
              </a:r>
              <a:endParaRPr b="0" lang="en-US" sz="2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7" name=""/>
            <p:cNvSpPr/>
            <p:nvPr/>
          </p:nvSpPr>
          <p:spPr>
            <a:xfrm>
              <a:off x="2603520" y="4584600"/>
              <a:ext cx="692640" cy="398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2000" spc="-1" strike="noStrike">
                  <a:solidFill>
                    <a:srgbClr val="ff0b02"/>
                  </a:solidFill>
                  <a:latin typeface="Times New Roman"/>
                </a:rPr>
                <a:t>733x</a:t>
              </a:r>
              <a:endParaRPr b="0" lang="en-US" sz="2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8" name=""/>
            <p:cNvSpPr/>
            <p:nvPr/>
          </p:nvSpPr>
          <p:spPr>
            <a:xfrm>
              <a:off x="2419200" y="4533840"/>
              <a:ext cx="152640" cy="533520"/>
            </a:xfrm>
            <a:custGeom>
              <a:avLst/>
              <a:gdLst>
                <a:gd name="textAreaLeft" fmla="*/ 20160 w 152640"/>
                <a:gd name="textAreaRight" fmla="*/ 132480 w 152640"/>
                <a:gd name="textAreaTop" fmla="*/ 93240 h 533520"/>
                <a:gd name="textAreaBottom" fmla="*/ 387000 h 533520"/>
              </a:gdLst>
              <a:ahLst/>
              <a:rect l="textAreaLeft" t="textAreaTop" r="textAreaRight" b="textAreaBottom"/>
              <a:pathLst>
                <a:path w="21600" h="21600">
                  <a:moveTo>
                    <a:pt x="0" y="0"/>
                  </a:moveTo>
                  <a:arcTo wR="21600" hR="7560" stAng="-5400000" swAng="5400000"/>
                  <a:lnTo>
                    <a:pt x="21600" y="11880"/>
                  </a:lnTo>
                  <a:arcTo wR="21600" hR="7560" stAng="0" swAng="2682637"/>
                  <a:lnTo>
                    <a:pt x="7200" y="21168"/>
                  </a:lnTo>
                  <a:lnTo>
                    <a:pt x="0" y="17280"/>
                  </a:lnTo>
                  <a:lnTo>
                    <a:pt x="7200" y="12528"/>
                  </a:lnTo>
                  <a:lnTo>
                    <a:pt x="7200" y="14688"/>
                  </a:lnTo>
                  <a:arcTo wR="21600" hR="7560" stAng="2682637" swAng="-2325203"/>
                  <a:lnTo>
                    <a:pt x="20700" y="9720"/>
                  </a:lnTo>
                  <a:arcTo wR="21600" hR="7560" stAng="-357435" swAng="-5042565"/>
                  <a:close/>
                </a:path>
                <a:path fill="darkenLess" w="21600" h="21600">
                  <a:moveTo>
                    <a:pt x="0" y="0"/>
                  </a:moveTo>
                  <a:arcTo wR="21600" hR="7560" stAng="-5400000" swAng="5400000"/>
                  <a:lnTo>
                    <a:pt x="21600" y="11880"/>
                  </a:lnTo>
                  <a:arcTo wR="21600" hR="7560" stAng="0" swAng="-357435"/>
                  <a:lnTo>
                    <a:pt x="20700" y="9720"/>
                  </a:lnTo>
                  <a:arcTo wR="21600" hR="7560" stAng="-357435" swAng="-5042565"/>
                  <a:close/>
                </a:path>
              </a:pathLst>
            </a:custGeom>
            <a:solidFill>
              <a:srgbClr val="bbe0e3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9" name=""/>
            <p:cNvSpPr/>
            <p:nvPr/>
          </p:nvSpPr>
          <p:spPr>
            <a:xfrm>
              <a:off x="2394000" y="3987720"/>
              <a:ext cx="152280" cy="533520"/>
            </a:xfrm>
            <a:custGeom>
              <a:avLst/>
              <a:gdLst>
                <a:gd name="textAreaLeft" fmla="*/ 20160 w 152280"/>
                <a:gd name="textAreaRight" fmla="*/ 132120 w 152280"/>
                <a:gd name="textAreaTop" fmla="*/ 93240 h 533520"/>
                <a:gd name="textAreaBottom" fmla="*/ 387000 h 533520"/>
              </a:gdLst>
              <a:ahLst/>
              <a:rect l="textAreaLeft" t="textAreaTop" r="textAreaRight" b="textAreaBottom"/>
              <a:pathLst>
                <a:path w="21600" h="21600">
                  <a:moveTo>
                    <a:pt x="0" y="0"/>
                  </a:moveTo>
                  <a:arcTo wR="21600" hR="7560" stAng="-5400000" swAng="5400000"/>
                  <a:lnTo>
                    <a:pt x="21600" y="11880"/>
                  </a:lnTo>
                  <a:arcTo wR="21600" hR="7560" stAng="0" swAng="2682637"/>
                  <a:lnTo>
                    <a:pt x="7200" y="21168"/>
                  </a:lnTo>
                  <a:lnTo>
                    <a:pt x="0" y="17280"/>
                  </a:lnTo>
                  <a:lnTo>
                    <a:pt x="7200" y="12528"/>
                  </a:lnTo>
                  <a:lnTo>
                    <a:pt x="7200" y="14688"/>
                  </a:lnTo>
                  <a:arcTo wR="21600" hR="7560" stAng="2682637" swAng="-2325203"/>
                  <a:lnTo>
                    <a:pt x="20700" y="9720"/>
                  </a:lnTo>
                  <a:arcTo wR="21600" hR="7560" stAng="-357435" swAng="-5042565"/>
                  <a:close/>
                </a:path>
                <a:path fill="darkenLess" w="21600" h="21600">
                  <a:moveTo>
                    <a:pt x="0" y="0"/>
                  </a:moveTo>
                  <a:arcTo wR="21600" hR="7560" stAng="-5400000" swAng="5400000"/>
                  <a:lnTo>
                    <a:pt x="21600" y="11880"/>
                  </a:lnTo>
                  <a:arcTo wR="21600" hR="7560" stAng="0" swAng="-357435"/>
                  <a:lnTo>
                    <a:pt x="20700" y="9720"/>
                  </a:lnTo>
                  <a:arcTo wR="21600" hR="7560" stAng="-357435" swAng="-5042565"/>
                  <a:close/>
                </a:path>
              </a:pathLst>
            </a:custGeom>
            <a:solidFill>
              <a:srgbClr val="bbe0e3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</p:grpSp>
      <p:grpSp>
        <p:nvGrpSpPr>
          <p:cNvPr id="70" name=""/>
          <p:cNvGrpSpPr/>
          <p:nvPr/>
        </p:nvGrpSpPr>
        <p:grpSpPr>
          <a:xfrm>
            <a:off x="3732840" y="1206360"/>
            <a:ext cx="2248920" cy="1739880"/>
            <a:chOff x="3732840" y="1206360"/>
            <a:chExt cx="2248920" cy="1739880"/>
          </a:xfrm>
        </p:grpSpPr>
        <p:sp>
          <p:nvSpPr>
            <p:cNvPr id="71" name=""/>
            <p:cNvSpPr/>
            <p:nvPr/>
          </p:nvSpPr>
          <p:spPr>
            <a:xfrm>
              <a:off x="3732840" y="1206360"/>
              <a:ext cx="1875240" cy="1739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5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 u="sng">
                  <a:solidFill>
                    <a:srgbClr val="000000"/>
                  </a:solidFill>
                  <a:uFillTx/>
                  <a:latin typeface="Times New Roman"/>
                </a:rPr>
                <a:t>ii Normalised data</a:t>
              </a:r>
              <a:endParaRPr b="0" lang="en-US" sz="1800" spc="-1" strike="noStrike">
                <a:solidFill>
                  <a:srgbClr val="000000"/>
                </a:solidFill>
                <a:latin typeface="Times New Roman"/>
              </a:endParaRPr>
            </a:p>
            <a:p>
              <a:pPr>
                <a:lnSpc>
                  <a:spcPct val="15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Times New Roman"/>
                </a:rPr>
                <a:t>127 PP: 2453</a:t>
              </a:r>
              <a:endParaRPr b="0" lang="en-US" sz="1800" spc="-1" strike="noStrike">
                <a:solidFill>
                  <a:srgbClr val="000000"/>
                </a:solidFill>
                <a:latin typeface="Times New Roman"/>
              </a:endParaRPr>
            </a:p>
            <a:p>
              <a:pPr>
                <a:lnSpc>
                  <a:spcPct val="15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Times New Roman"/>
                </a:rPr>
                <a:t>131 PP: 1036</a:t>
              </a:r>
              <a:endParaRPr b="0" lang="en-US" sz="1800" spc="-1" strike="noStrike">
                <a:solidFill>
                  <a:srgbClr val="000000"/>
                </a:solidFill>
                <a:latin typeface="Times New Roman"/>
              </a:endParaRPr>
            </a:p>
            <a:p>
              <a:pPr>
                <a:lnSpc>
                  <a:spcPct val="15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Times New Roman"/>
                </a:rPr>
                <a:t>137 PP: 318</a:t>
              </a:r>
              <a:endParaRPr b="0" lang="en-US" sz="1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2" name=""/>
            <p:cNvSpPr/>
            <p:nvPr/>
          </p:nvSpPr>
          <p:spPr>
            <a:xfrm>
              <a:off x="5334120" y="1788840"/>
              <a:ext cx="628920" cy="398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2000" spc="-1" strike="noStrike">
                  <a:solidFill>
                    <a:srgbClr val="ff0b02"/>
                  </a:solidFill>
                  <a:latin typeface="Times New Roman"/>
                </a:rPr>
                <a:t>2.4x</a:t>
              </a:r>
              <a:endParaRPr b="0" lang="en-US" sz="2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3" name=""/>
            <p:cNvSpPr/>
            <p:nvPr/>
          </p:nvSpPr>
          <p:spPr>
            <a:xfrm>
              <a:off x="5352840" y="2360520"/>
              <a:ext cx="628920" cy="398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2000" spc="-1" strike="noStrike">
                  <a:solidFill>
                    <a:srgbClr val="ff0b02"/>
                  </a:solidFill>
                  <a:latin typeface="Times New Roman"/>
                </a:rPr>
                <a:t>3.3x</a:t>
              </a:r>
              <a:endParaRPr b="0" lang="en-US" sz="2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4" name=""/>
            <p:cNvSpPr/>
            <p:nvPr/>
          </p:nvSpPr>
          <p:spPr>
            <a:xfrm>
              <a:off x="5168880" y="2309760"/>
              <a:ext cx="152280" cy="533160"/>
            </a:xfrm>
            <a:custGeom>
              <a:avLst/>
              <a:gdLst>
                <a:gd name="textAreaLeft" fmla="*/ 20160 w 152280"/>
                <a:gd name="textAreaRight" fmla="*/ 132120 w 152280"/>
                <a:gd name="textAreaTop" fmla="*/ 93240 h 533160"/>
                <a:gd name="textAreaBottom" fmla="*/ 386640 h 533160"/>
              </a:gdLst>
              <a:ahLst/>
              <a:rect l="textAreaLeft" t="textAreaTop" r="textAreaRight" b="textAreaBottom"/>
              <a:pathLst>
                <a:path w="21600" h="21600">
                  <a:moveTo>
                    <a:pt x="0" y="0"/>
                  </a:moveTo>
                  <a:arcTo wR="21600" hR="7560" stAng="-5400000" swAng="5400000"/>
                  <a:lnTo>
                    <a:pt x="21600" y="11880"/>
                  </a:lnTo>
                  <a:arcTo wR="21600" hR="7560" stAng="0" swAng="2682637"/>
                  <a:lnTo>
                    <a:pt x="7200" y="21168"/>
                  </a:lnTo>
                  <a:lnTo>
                    <a:pt x="0" y="17280"/>
                  </a:lnTo>
                  <a:lnTo>
                    <a:pt x="7200" y="12528"/>
                  </a:lnTo>
                  <a:lnTo>
                    <a:pt x="7200" y="14688"/>
                  </a:lnTo>
                  <a:arcTo wR="21600" hR="7560" stAng="2682637" swAng="-2325203"/>
                  <a:lnTo>
                    <a:pt x="20700" y="9720"/>
                  </a:lnTo>
                  <a:arcTo wR="21600" hR="7560" stAng="-357435" swAng="-5042565"/>
                  <a:close/>
                </a:path>
                <a:path fill="darkenLess" w="21600" h="21600">
                  <a:moveTo>
                    <a:pt x="0" y="0"/>
                  </a:moveTo>
                  <a:arcTo wR="21600" hR="7560" stAng="-5400000" swAng="5400000"/>
                  <a:lnTo>
                    <a:pt x="21600" y="11880"/>
                  </a:lnTo>
                  <a:arcTo wR="21600" hR="7560" stAng="0" swAng="-357435"/>
                  <a:lnTo>
                    <a:pt x="20700" y="9720"/>
                  </a:lnTo>
                  <a:arcTo wR="21600" hR="7560" stAng="-357435" swAng="-5042565"/>
                  <a:close/>
                </a:path>
              </a:pathLst>
            </a:custGeom>
            <a:solidFill>
              <a:srgbClr val="bbe0e3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5" name=""/>
            <p:cNvSpPr/>
            <p:nvPr/>
          </p:nvSpPr>
          <p:spPr>
            <a:xfrm>
              <a:off x="5143320" y="1763640"/>
              <a:ext cx="152640" cy="533160"/>
            </a:xfrm>
            <a:custGeom>
              <a:avLst/>
              <a:gdLst>
                <a:gd name="textAreaLeft" fmla="*/ 20160 w 152640"/>
                <a:gd name="textAreaRight" fmla="*/ 132480 w 152640"/>
                <a:gd name="textAreaTop" fmla="*/ 93240 h 533160"/>
                <a:gd name="textAreaBottom" fmla="*/ 386640 h 533160"/>
              </a:gdLst>
              <a:ahLst/>
              <a:rect l="textAreaLeft" t="textAreaTop" r="textAreaRight" b="textAreaBottom"/>
              <a:pathLst>
                <a:path w="21600" h="21600">
                  <a:moveTo>
                    <a:pt x="0" y="0"/>
                  </a:moveTo>
                  <a:arcTo wR="21600" hR="7560" stAng="-5400000" swAng="5400000"/>
                  <a:lnTo>
                    <a:pt x="21600" y="11880"/>
                  </a:lnTo>
                  <a:arcTo wR="21600" hR="7560" stAng="0" swAng="2682637"/>
                  <a:lnTo>
                    <a:pt x="7200" y="21168"/>
                  </a:lnTo>
                  <a:lnTo>
                    <a:pt x="0" y="17280"/>
                  </a:lnTo>
                  <a:lnTo>
                    <a:pt x="7200" y="12528"/>
                  </a:lnTo>
                  <a:lnTo>
                    <a:pt x="7200" y="14688"/>
                  </a:lnTo>
                  <a:arcTo wR="21600" hR="7560" stAng="2682637" swAng="-2325203"/>
                  <a:lnTo>
                    <a:pt x="20700" y="9720"/>
                  </a:lnTo>
                  <a:arcTo wR="21600" hR="7560" stAng="-357435" swAng="-5042565"/>
                  <a:close/>
                </a:path>
                <a:path fill="darkenLess" w="21600" h="21600">
                  <a:moveTo>
                    <a:pt x="0" y="0"/>
                  </a:moveTo>
                  <a:arcTo wR="21600" hR="7560" stAng="-5400000" swAng="5400000"/>
                  <a:lnTo>
                    <a:pt x="21600" y="11880"/>
                  </a:lnTo>
                  <a:arcTo wR="21600" hR="7560" stAng="0" swAng="-357435"/>
                  <a:lnTo>
                    <a:pt x="20700" y="9720"/>
                  </a:lnTo>
                  <a:arcTo wR="21600" hR="7560" stAng="-357435" swAng="-5042565"/>
                  <a:close/>
                </a:path>
              </a:pathLst>
            </a:custGeom>
            <a:solidFill>
              <a:srgbClr val="bbe0e3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</p:grpSp>
      <p:grpSp>
        <p:nvGrpSpPr>
          <p:cNvPr id="76" name=""/>
          <p:cNvGrpSpPr/>
          <p:nvPr/>
        </p:nvGrpSpPr>
        <p:grpSpPr>
          <a:xfrm>
            <a:off x="3733920" y="3390840"/>
            <a:ext cx="2178000" cy="1739880"/>
            <a:chOff x="3733920" y="3390840"/>
            <a:chExt cx="2178000" cy="1739880"/>
          </a:xfrm>
        </p:grpSpPr>
        <p:sp>
          <p:nvSpPr>
            <p:cNvPr id="77" name=""/>
            <p:cNvSpPr/>
            <p:nvPr/>
          </p:nvSpPr>
          <p:spPr>
            <a:xfrm>
              <a:off x="3733920" y="3390840"/>
              <a:ext cx="2178000" cy="1739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5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 u="sng">
                  <a:solidFill>
                    <a:srgbClr val="000000"/>
                  </a:solidFill>
                  <a:uFillTx/>
                  <a:latin typeface="Times New Roman"/>
                </a:rPr>
                <a:t>iv Normalised data</a:t>
              </a:r>
              <a:endParaRPr b="0" lang="en-US" sz="1800" spc="-1" strike="noStrike">
                <a:solidFill>
                  <a:srgbClr val="000000"/>
                </a:solidFill>
                <a:latin typeface="Times New Roman"/>
              </a:endParaRPr>
            </a:p>
            <a:p>
              <a:pPr>
                <a:lnSpc>
                  <a:spcPct val="15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Times New Roman"/>
                </a:rPr>
                <a:t>127 T: 107</a:t>
              </a:r>
              <a:endParaRPr b="0" lang="en-US" sz="1800" spc="-1" strike="noStrike">
                <a:solidFill>
                  <a:srgbClr val="000000"/>
                </a:solidFill>
                <a:latin typeface="Times New Roman"/>
              </a:endParaRPr>
            </a:p>
            <a:p>
              <a:pPr>
                <a:lnSpc>
                  <a:spcPct val="15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Times New Roman"/>
                </a:rPr>
                <a:t>131 T: 96</a:t>
              </a:r>
              <a:endParaRPr b="0" lang="en-US" sz="1800" spc="-1" strike="noStrike">
                <a:solidFill>
                  <a:srgbClr val="000000"/>
                </a:solidFill>
                <a:latin typeface="Times New Roman"/>
              </a:endParaRPr>
            </a:p>
            <a:p>
              <a:pPr>
                <a:lnSpc>
                  <a:spcPct val="15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Times New Roman"/>
                </a:rPr>
                <a:t>137 T: 22</a:t>
              </a:r>
              <a:endParaRPr b="0" lang="en-US" sz="1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8" name=""/>
            <p:cNvSpPr/>
            <p:nvPr/>
          </p:nvSpPr>
          <p:spPr>
            <a:xfrm>
              <a:off x="5181480" y="4003560"/>
              <a:ext cx="628920" cy="398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2000" spc="-1" strike="noStrike">
                  <a:solidFill>
                    <a:srgbClr val="ff0b02"/>
                  </a:solidFill>
                  <a:latin typeface="Times New Roman"/>
                </a:rPr>
                <a:t>1.1x</a:t>
              </a:r>
              <a:endParaRPr b="0" lang="en-US" sz="2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9" name=""/>
            <p:cNvSpPr/>
            <p:nvPr/>
          </p:nvSpPr>
          <p:spPr>
            <a:xfrm>
              <a:off x="5200560" y="4575240"/>
              <a:ext cx="628920" cy="398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2000" spc="-1" strike="noStrike">
                  <a:solidFill>
                    <a:srgbClr val="ff0b02"/>
                  </a:solidFill>
                  <a:latin typeface="Times New Roman"/>
                </a:rPr>
                <a:t>4.4x</a:t>
              </a:r>
              <a:endParaRPr b="0" lang="en-US" sz="2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0" name=""/>
            <p:cNvSpPr/>
            <p:nvPr/>
          </p:nvSpPr>
          <p:spPr>
            <a:xfrm>
              <a:off x="5016600" y="4524480"/>
              <a:ext cx="152280" cy="533160"/>
            </a:xfrm>
            <a:custGeom>
              <a:avLst/>
              <a:gdLst>
                <a:gd name="textAreaLeft" fmla="*/ 20160 w 152280"/>
                <a:gd name="textAreaRight" fmla="*/ 132120 w 152280"/>
                <a:gd name="textAreaTop" fmla="*/ 93240 h 533160"/>
                <a:gd name="textAreaBottom" fmla="*/ 386640 h 533160"/>
              </a:gdLst>
              <a:ahLst/>
              <a:rect l="textAreaLeft" t="textAreaTop" r="textAreaRight" b="textAreaBottom"/>
              <a:pathLst>
                <a:path w="21600" h="21600">
                  <a:moveTo>
                    <a:pt x="0" y="0"/>
                  </a:moveTo>
                  <a:arcTo wR="21600" hR="7560" stAng="-5400000" swAng="5400000"/>
                  <a:lnTo>
                    <a:pt x="21600" y="11880"/>
                  </a:lnTo>
                  <a:arcTo wR="21600" hR="7560" stAng="0" swAng="2682637"/>
                  <a:lnTo>
                    <a:pt x="7200" y="21168"/>
                  </a:lnTo>
                  <a:lnTo>
                    <a:pt x="0" y="17280"/>
                  </a:lnTo>
                  <a:lnTo>
                    <a:pt x="7200" y="12528"/>
                  </a:lnTo>
                  <a:lnTo>
                    <a:pt x="7200" y="14688"/>
                  </a:lnTo>
                  <a:arcTo wR="21600" hR="7560" stAng="2682637" swAng="-2325203"/>
                  <a:lnTo>
                    <a:pt x="20700" y="9720"/>
                  </a:lnTo>
                  <a:arcTo wR="21600" hR="7560" stAng="-357435" swAng="-5042565"/>
                  <a:close/>
                </a:path>
                <a:path fill="darkenLess" w="21600" h="21600">
                  <a:moveTo>
                    <a:pt x="0" y="0"/>
                  </a:moveTo>
                  <a:arcTo wR="21600" hR="7560" stAng="-5400000" swAng="5400000"/>
                  <a:lnTo>
                    <a:pt x="21600" y="11880"/>
                  </a:lnTo>
                  <a:arcTo wR="21600" hR="7560" stAng="0" swAng="-357435"/>
                  <a:lnTo>
                    <a:pt x="20700" y="9720"/>
                  </a:lnTo>
                  <a:arcTo wR="21600" hR="7560" stAng="-357435" swAng="-5042565"/>
                  <a:close/>
                </a:path>
              </a:pathLst>
            </a:custGeom>
            <a:solidFill>
              <a:srgbClr val="bbe0e3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1" name=""/>
            <p:cNvSpPr/>
            <p:nvPr/>
          </p:nvSpPr>
          <p:spPr>
            <a:xfrm>
              <a:off x="4991040" y="3978360"/>
              <a:ext cx="152640" cy="533160"/>
            </a:xfrm>
            <a:custGeom>
              <a:avLst/>
              <a:gdLst>
                <a:gd name="textAreaLeft" fmla="*/ 20160 w 152640"/>
                <a:gd name="textAreaRight" fmla="*/ 132480 w 152640"/>
                <a:gd name="textAreaTop" fmla="*/ 93240 h 533160"/>
                <a:gd name="textAreaBottom" fmla="*/ 386640 h 533160"/>
              </a:gdLst>
              <a:ahLst/>
              <a:rect l="textAreaLeft" t="textAreaTop" r="textAreaRight" b="textAreaBottom"/>
              <a:pathLst>
                <a:path w="21600" h="21600">
                  <a:moveTo>
                    <a:pt x="0" y="0"/>
                  </a:moveTo>
                  <a:arcTo wR="21600" hR="7560" stAng="-5400000" swAng="5400000"/>
                  <a:lnTo>
                    <a:pt x="21600" y="11880"/>
                  </a:lnTo>
                  <a:arcTo wR="21600" hR="7560" stAng="0" swAng="2682637"/>
                  <a:lnTo>
                    <a:pt x="7200" y="21168"/>
                  </a:lnTo>
                  <a:lnTo>
                    <a:pt x="0" y="17280"/>
                  </a:lnTo>
                  <a:lnTo>
                    <a:pt x="7200" y="12528"/>
                  </a:lnTo>
                  <a:lnTo>
                    <a:pt x="7200" y="14688"/>
                  </a:lnTo>
                  <a:arcTo wR="21600" hR="7560" stAng="2682637" swAng="-2325203"/>
                  <a:lnTo>
                    <a:pt x="20700" y="9720"/>
                  </a:lnTo>
                  <a:arcTo wR="21600" hR="7560" stAng="-357435" swAng="-5042565"/>
                  <a:close/>
                </a:path>
                <a:path fill="darkenLess" w="21600" h="21600">
                  <a:moveTo>
                    <a:pt x="0" y="0"/>
                  </a:moveTo>
                  <a:arcTo wR="21600" hR="7560" stAng="-5400000" swAng="5400000"/>
                  <a:lnTo>
                    <a:pt x="21600" y="11880"/>
                  </a:lnTo>
                  <a:arcTo wR="21600" hR="7560" stAng="0" swAng="-357435"/>
                  <a:lnTo>
                    <a:pt x="20700" y="9720"/>
                  </a:lnTo>
                  <a:arcTo wR="21600" hR="7560" stAng="-357435" swAng="-5042565"/>
                  <a:close/>
                </a:path>
              </a:pathLst>
            </a:custGeom>
            <a:solidFill>
              <a:srgbClr val="bbe0e3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204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6-10-16T15:35:40Z</dcterms:created>
  <dc:creator>Joanna B. Wilson</dc:creator>
  <dc:description/>
  <dc:language>en-US</dc:language>
  <cp:lastModifiedBy>Joanna Wilson</cp:lastModifiedBy>
  <cp:lastPrinted>2006-10-24T23:40:24Z</cp:lastPrinted>
  <dcterms:modified xsi:type="dcterms:W3CDTF">2010-01-18T16:44:49Z</dcterms:modified>
  <cp:revision>74</cp:revision>
  <dc:subject/>
  <dc:title>PowerPoint Presentation</dc:title>
</cp:coreProperties>
</file>